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&#32974;&#20799;&#21307;&#23398;&#31185;\11.&#29983;&#38271;&#26354;&#32447;\BMC%20Pregnancy%20and%20Childbirth\review2021.3.8\IVF&#21644;&#33258;&#28982;&#21463;&#23381;&#30340;&#27604;&#3673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248912915736286E-2"/>
          <c:y val="0.1066807842201543"/>
          <c:w val="0.81446602725451489"/>
          <c:h val="0.77962742228244197"/>
        </c:manualLayout>
      </c:layout>
      <c:lineChart>
        <c:grouping val="standard"/>
        <c:varyColors val="0"/>
        <c:ser>
          <c:idx val="1"/>
          <c:order val="0"/>
          <c:tx>
            <c:strRef>
              <c:f>'[1]Sheet1(只做14w以后的)'!$B$555</c:f>
              <c:strCache>
                <c:ptCount val="1"/>
                <c:pt idx="0">
                  <c:v>10th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B$556:$B$580</c:f>
              <c:numCache>
                <c:formatCode>General</c:formatCode>
                <c:ptCount val="25"/>
                <c:pt idx="0">
                  <c:v>85.34</c:v>
                </c:pt>
                <c:pt idx="1">
                  <c:v>106.39</c:v>
                </c:pt>
                <c:pt idx="2">
                  <c:v>131.72</c:v>
                </c:pt>
                <c:pt idx="3">
                  <c:v>161.97</c:v>
                </c:pt>
                <c:pt idx="4">
                  <c:v>197.8</c:v>
                </c:pt>
                <c:pt idx="5">
                  <c:v>239.9</c:v>
                </c:pt>
                <c:pt idx="6">
                  <c:v>288.95999999999998</c:v>
                </c:pt>
                <c:pt idx="7">
                  <c:v>345.66</c:v>
                </c:pt>
                <c:pt idx="8">
                  <c:v>410.65</c:v>
                </c:pt>
                <c:pt idx="9">
                  <c:v>484.51</c:v>
                </c:pt>
                <c:pt idx="10">
                  <c:v>567.74</c:v>
                </c:pt>
                <c:pt idx="11">
                  <c:v>660.69</c:v>
                </c:pt>
                <c:pt idx="12">
                  <c:v>763.59</c:v>
                </c:pt>
                <c:pt idx="13">
                  <c:v>876.46</c:v>
                </c:pt>
                <c:pt idx="14">
                  <c:v>999.1</c:v>
                </c:pt>
                <c:pt idx="15">
                  <c:v>1131.0999999999999</c:v>
                </c:pt>
                <c:pt idx="16">
                  <c:v>1271.74</c:v>
                </c:pt>
                <c:pt idx="17">
                  <c:v>1420.05</c:v>
                </c:pt>
                <c:pt idx="18">
                  <c:v>1574.78</c:v>
                </c:pt>
                <c:pt idx="19">
                  <c:v>1734.39</c:v>
                </c:pt>
                <c:pt idx="20">
                  <c:v>1897.06</c:v>
                </c:pt>
                <c:pt idx="21">
                  <c:v>2060.75</c:v>
                </c:pt>
                <c:pt idx="22">
                  <c:v>2223.21</c:v>
                </c:pt>
                <c:pt idx="23">
                  <c:v>2382.0100000000002</c:v>
                </c:pt>
                <c:pt idx="24">
                  <c:v>2534.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29E-4E28-A36F-3469303E4FFC}"/>
            </c:ext>
          </c:extLst>
        </c:ser>
        <c:ser>
          <c:idx val="2"/>
          <c:order val="1"/>
          <c:tx>
            <c:strRef>
              <c:f>'[1]Sheet1(只做14w以后的)'!$C$555</c:f>
              <c:strCache>
                <c:ptCount val="1"/>
                <c:pt idx="0">
                  <c:v>50th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C$556:$C$580</c:f>
              <c:numCache>
                <c:formatCode>General</c:formatCode>
                <c:ptCount val="25"/>
                <c:pt idx="0">
                  <c:v>95.95</c:v>
                </c:pt>
                <c:pt idx="1">
                  <c:v>119.63</c:v>
                </c:pt>
                <c:pt idx="2">
                  <c:v>148.12</c:v>
                </c:pt>
                <c:pt idx="3">
                  <c:v>182.15</c:v>
                </c:pt>
                <c:pt idx="4">
                  <c:v>222.46</c:v>
                </c:pt>
                <c:pt idx="5">
                  <c:v>269.82</c:v>
                </c:pt>
                <c:pt idx="6">
                  <c:v>325.02</c:v>
                </c:pt>
                <c:pt idx="7">
                  <c:v>388.83</c:v>
                </c:pt>
                <c:pt idx="8">
                  <c:v>461.97</c:v>
                </c:pt>
                <c:pt idx="9">
                  <c:v>545.11</c:v>
                </c:pt>
                <c:pt idx="10">
                  <c:v>638.78</c:v>
                </c:pt>
                <c:pt idx="11">
                  <c:v>743.42</c:v>
                </c:pt>
                <c:pt idx="12">
                  <c:v>859.27</c:v>
                </c:pt>
                <c:pt idx="13">
                  <c:v>986.35</c:v>
                </c:pt>
                <c:pt idx="14">
                  <c:v>1124.45</c:v>
                </c:pt>
                <c:pt idx="15">
                  <c:v>1273.0899999999999</c:v>
                </c:pt>
                <c:pt idx="16">
                  <c:v>1431.49</c:v>
                </c:pt>
                <c:pt idx="17">
                  <c:v>1598.55</c:v>
                </c:pt>
                <c:pt idx="18">
                  <c:v>1772.86</c:v>
                </c:pt>
                <c:pt idx="19">
                  <c:v>1952.67</c:v>
                </c:pt>
                <c:pt idx="20">
                  <c:v>2135.9699999999998</c:v>
                </c:pt>
                <c:pt idx="21">
                  <c:v>2320.44</c:v>
                </c:pt>
                <c:pt idx="22">
                  <c:v>2503.54</c:v>
                </c:pt>
                <c:pt idx="23">
                  <c:v>2682.56</c:v>
                </c:pt>
                <c:pt idx="24">
                  <c:v>2854.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29E-4E28-A36F-3469303E4FFC}"/>
            </c:ext>
          </c:extLst>
        </c:ser>
        <c:ser>
          <c:idx val="3"/>
          <c:order val="2"/>
          <c:tx>
            <c:strRef>
              <c:f>'[1]Sheet1(只做14w以后的)'!$D$555</c:f>
              <c:strCache>
                <c:ptCount val="1"/>
                <c:pt idx="0">
                  <c:v>90th</c:v>
                </c:pt>
              </c:strCache>
            </c:strRef>
          </c:tx>
          <c:spPr>
            <a:ln>
              <a:solidFill>
                <a:srgbClr val="C00000"/>
              </a:solidFill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D$556:$D$580</c:f>
              <c:numCache>
                <c:formatCode>General</c:formatCode>
                <c:ptCount val="25"/>
                <c:pt idx="0">
                  <c:v>107.88</c:v>
                </c:pt>
                <c:pt idx="1">
                  <c:v>134.51</c:v>
                </c:pt>
                <c:pt idx="2">
                  <c:v>166.57</c:v>
                </c:pt>
                <c:pt idx="3">
                  <c:v>204.84</c:v>
                </c:pt>
                <c:pt idx="4">
                  <c:v>250.19</c:v>
                </c:pt>
                <c:pt idx="5">
                  <c:v>303.48</c:v>
                </c:pt>
                <c:pt idx="6">
                  <c:v>365.59</c:v>
                </c:pt>
                <c:pt idx="7">
                  <c:v>437.4</c:v>
                </c:pt>
                <c:pt idx="8">
                  <c:v>519.71</c:v>
                </c:pt>
                <c:pt idx="9">
                  <c:v>613.27</c:v>
                </c:pt>
                <c:pt idx="10">
                  <c:v>718.72</c:v>
                </c:pt>
                <c:pt idx="11">
                  <c:v>836.51</c:v>
                </c:pt>
                <c:pt idx="12">
                  <c:v>966.93</c:v>
                </c:pt>
                <c:pt idx="13">
                  <c:v>1110.01</c:v>
                </c:pt>
                <c:pt idx="14">
                  <c:v>1265.52</c:v>
                </c:pt>
                <c:pt idx="15">
                  <c:v>1432.91</c:v>
                </c:pt>
                <c:pt idx="16">
                  <c:v>1611.31</c:v>
                </c:pt>
                <c:pt idx="17">
                  <c:v>1799.48</c:v>
                </c:pt>
                <c:pt idx="18">
                  <c:v>1995.84</c:v>
                </c:pt>
                <c:pt idx="19">
                  <c:v>2198.4299999999998</c:v>
                </c:pt>
                <c:pt idx="20">
                  <c:v>2404.9699999999998</c:v>
                </c:pt>
                <c:pt idx="21">
                  <c:v>2612.86</c:v>
                </c:pt>
                <c:pt idx="22">
                  <c:v>2819.23</c:v>
                </c:pt>
                <c:pt idx="23">
                  <c:v>3021.03</c:v>
                </c:pt>
                <c:pt idx="24">
                  <c:v>3215.0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29E-4E28-A36F-3469303E4FFC}"/>
            </c:ext>
          </c:extLst>
        </c:ser>
        <c:ser>
          <c:idx val="4"/>
          <c:order val="3"/>
          <c:tx>
            <c:strRef>
              <c:f>'[1]Sheet1(只做14w以后的)'!$E$555</c:f>
              <c:strCache>
                <c:ptCount val="1"/>
                <c:pt idx="0">
                  <c:v>10th</c:v>
                </c:pt>
              </c:strCache>
            </c:strRef>
          </c:tx>
          <c:spPr>
            <a:ln>
              <a:solidFill>
                <a:srgbClr val="7030A0"/>
              </a:solidFill>
              <a:prstDash val="dash"/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E$556:$E$580</c:f>
              <c:numCache>
                <c:formatCode>General</c:formatCode>
                <c:ptCount val="25"/>
                <c:pt idx="0">
                  <c:v>86.29</c:v>
                </c:pt>
                <c:pt idx="1">
                  <c:v>107.47</c:v>
                </c:pt>
                <c:pt idx="2">
                  <c:v>132.94</c:v>
                </c:pt>
                <c:pt idx="3">
                  <c:v>163.31</c:v>
                </c:pt>
                <c:pt idx="4">
                  <c:v>199.27</c:v>
                </c:pt>
                <c:pt idx="5">
                  <c:v>241.49</c:v>
                </c:pt>
                <c:pt idx="6">
                  <c:v>290.66000000000003</c:v>
                </c:pt>
                <c:pt idx="7">
                  <c:v>347.46</c:v>
                </c:pt>
                <c:pt idx="8">
                  <c:v>412.54</c:v>
                </c:pt>
                <c:pt idx="9">
                  <c:v>486.47</c:v>
                </c:pt>
                <c:pt idx="10">
                  <c:v>569.74</c:v>
                </c:pt>
                <c:pt idx="11">
                  <c:v>662.74</c:v>
                </c:pt>
                <c:pt idx="12">
                  <c:v>765.67</c:v>
                </c:pt>
                <c:pt idx="13">
                  <c:v>878.56</c:v>
                </c:pt>
                <c:pt idx="14">
                  <c:v>1001.24</c:v>
                </c:pt>
                <c:pt idx="15">
                  <c:v>1133.28</c:v>
                </c:pt>
                <c:pt idx="16">
                  <c:v>1274.01</c:v>
                </c:pt>
                <c:pt idx="17">
                  <c:v>1422.48</c:v>
                </c:pt>
                <c:pt idx="18">
                  <c:v>1577.43</c:v>
                </c:pt>
                <c:pt idx="19">
                  <c:v>1737.37</c:v>
                </c:pt>
                <c:pt idx="20">
                  <c:v>1900.5</c:v>
                </c:pt>
                <c:pt idx="21">
                  <c:v>2064.8000000000002</c:v>
                </c:pt>
                <c:pt idx="22">
                  <c:v>2228.04</c:v>
                </c:pt>
                <c:pt idx="23">
                  <c:v>2387.83</c:v>
                </c:pt>
                <c:pt idx="24">
                  <c:v>2541.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29E-4E28-A36F-3469303E4FFC}"/>
            </c:ext>
          </c:extLst>
        </c:ser>
        <c:ser>
          <c:idx val="5"/>
          <c:order val="4"/>
          <c:tx>
            <c:strRef>
              <c:f>'[1]Sheet1(只做14w以后的)'!$F$555</c:f>
              <c:strCache>
                <c:ptCount val="1"/>
                <c:pt idx="0">
                  <c:v>50th</c:v>
                </c:pt>
              </c:strCache>
            </c:strRef>
          </c:tx>
          <c:spPr>
            <a:ln>
              <a:solidFill>
                <a:srgbClr val="7030A0"/>
              </a:solidFill>
              <a:prstDash val="dash"/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F$556:$F$580</c:f>
              <c:numCache>
                <c:formatCode>General</c:formatCode>
                <c:ptCount val="25"/>
                <c:pt idx="0">
                  <c:v>96.94</c:v>
                </c:pt>
                <c:pt idx="1">
                  <c:v>120.76</c:v>
                </c:pt>
                <c:pt idx="2">
                  <c:v>149.41</c:v>
                </c:pt>
                <c:pt idx="3">
                  <c:v>183.61</c:v>
                </c:pt>
                <c:pt idx="4">
                  <c:v>224.09</c:v>
                </c:pt>
                <c:pt idx="5">
                  <c:v>271.64</c:v>
                </c:pt>
                <c:pt idx="6">
                  <c:v>327.04000000000002</c:v>
                </c:pt>
                <c:pt idx="7">
                  <c:v>391.06</c:v>
                </c:pt>
                <c:pt idx="8">
                  <c:v>464.43</c:v>
                </c:pt>
                <c:pt idx="9">
                  <c:v>547.80999999999995</c:v>
                </c:pt>
                <c:pt idx="10">
                  <c:v>641.76</c:v>
                </c:pt>
                <c:pt idx="11">
                  <c:v>746.71</c:v>
                </c:pt>
                <c:pt idx="12">
                  <c:v>862.92</c:v>
                </c:pt>
                <c:pt idx="13">
                  <c:v>990.41</c:v>
                </c:pt>
                <c:pt idx="14">
                  <c:v>1129.02</c:v>
                </c:pt>
                <c:pt idx="15">
                  <c:v>1278.26</c:v>
                </c:pt>
                <c:pt idx="16">
                  <c:v>1437.39</c:v>
                </c:pt>
                <c:pt idx="17">
                  <c:v>1605.32</c:v>
                </c:pt>
                <c:pt idx="18">
                  <c:v>1780.68</c:v>
                </c:pt>
                <c:pt idx="19">
                  <c:v>1961.75</c:v>
                </c:pt>
                <c:pt idx="20">
                  <c:v>2146.5300000000002</c:v>
                </c:pt>
                <c:pt idx="21">
                  <c:v>2332.73</c:v>
                </c:pt>
                <c:pt idx="22">
                  <c:v>2517.84</c:v>
                </c:pt>
                <c:pt idx="23">
                  <c:v>2699.14</c:v>
                </c:pt>
                <c:pt idx="24">
                  <c:v>2873.8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29E-4E28-A36F-3469303E4FFC}"/>
            </c:ext>
          </c:extLst>
        </c:ser>
        <c:ser>
          <c:idx val="6"/>
          <c:order val="5"/>
          <c:tx>
            <c:strRef>
              <c:f>'[1]Sheet1(只做14w以后的)'!$G$555</c:f>
              <c:strCache>
                <c:ptCount val="1"/>
                <c:pt idx="0">
                  <c:v>90th</c:v>
                </c:pt>
              </c:strCache>
            </c:strRef>
          </c:tx>
          <c:spPr>
            <a:ln>
              <a:solidFill>
                <a:srgbClr val="7030A0"/>
              </a:solidFill>
              <a:prstDash val="dash"/>
            </a:ln>
          </c:spPr>
          <c:marker>
            <c:symbol val="none"/>
          </c:marker>
          <c:cat>
            <c:numRef>
              <c:f>'[1]Sheet1(只做14w以后的)'!$A$556:$A$580</c:f>
              <c:numCache>
                <c:formatCode>General</c:formatCode>
                <c:ptCount val="25"/>
                <c:pt idx="0">
                  <c:v>14</c:v>
                </c:pt>
                <c:pt idx="1">
                  <c:v>15</c:v>
                </c:pt>
                <c:pt idx="2">
                  <c:v>16</c:v>
                </c:pt>
                <c:pt idx="3">
                  <c:v>17</c:v>
                </c:pt>
                <c:pt idx="4">
                  <c:v>18</c:v>
                </c:pt>
                <c:pt idx="5">
                  <c:v>19</c:v>
                </c:pt>
                <c:pt idx="6">
                  <c:v>20</c:v>
                </c:pt>
                <c:pt idx="7">
                  <c:v>21</c:v>
                </c:pt>
                <c:pt idx="8">
                  <c:v>22</c:v>
                </c:pt>
                <c:pt idx="9">
                  <c:v>23</c:v>
                </c:pt>
                <c:pt idx="10">
                  <c:v>24</c:v>
                </c:pt>
                <c:pt idx="11">
                  <c:v>25</c:v>
                </c:pt>
                <c:pt idx="12">
                  <c:v>26</c:v>
                </c:pt>
                <c:pt idx="13">
                  <c:v>27</c:v>
                </c:pt>
                <c:pt idx="14">
                  <c:v>28</c:v>
                </c:pt>
                <c:pt idx="15">
                  <c:v>29</c:v>
                </c:pt>
                <c:pt idx="16">
                  <c:v>30</c:v>
                </c:pt>
                <c:pt idx="17">
                  <c:v>31</c:v>
                </c:pt>
                <c:pt idx="18">
                  <c:v>32</c:v>
                </c:pt>
                <c:pt idx="19">
                  <c:v>33</c:v>
                </c:pt>
                <c:pt idx="20">
                  <c:v>34</c:v>
                </c:pt>
                <c:pt idx="21">
                  <c:v>35</c:v>
                </c:pt>
                <c:pt idx="22">
                  <c:v>36</c:v>
                </c:pt>
                <c:pt idx="23">
                  <c:v>37</c:v>
                </c:pt>
                <c:pt idx="24">
                  <c:v>38</c:v>
                </c:pt>
              </c:numCache>
            </c:numRef>
          </c:cat>
          <c:val>
            <c:numRef>
              <c:f>'[1]Sheet1(只做14w以后的)'!$G$556:$G$580</c:f>
              <c:numCache>
                <c:formatCode>General</c:formatCode>
                <c:ptCount val="25"/>
                <c:pt idx="0">
                  <c:v>108.9</c:v>
                </c:pt>
                <c:pt idx="1">
                  <c:v>135.69</c:v>
                </c:pt>
                <c:pt idx="2">
                  <c:v>167.94</c:v>
                </c:pt>
                <c:pt idx="3">
                  <c:v>206.43</c:v>
                </c:pt>
                <c:pt idx="4">
                  <c:v>252.01</c:v>
                </c:pt>
                <c:pt idx="5">
                  <c:v>305.57</c:v>
                </c:pt>
                <c:pt idx="6">
                  <c:v>367.98</c:v>
                </c:pt>
                <c:pt idx="7">
                  <c:v>440.14</c:v>
                </c:pt>
                <c:pt idx="8">
                  <c:v>522.85</c:v>
                </c:pt>
                <c:pt idx="9">
                  <c:v>616.89</c:v>
                </c:pt>
                <c:pt idx="10">
                  <c:v>722.88</c:v>
                </c:pt>
                <c:pt idx="11">
                  <c:v>841.33</c:v>
                </c:pt>
                <c:pt idx="12">
                  <c:v>972.52</c:v>
                </c:pt>
                <c:pt idx="13">
                  <c:v>1116.51</c:v>
                </c:pt>
                <c:pt idx="14">
                  <c:v>1273.1099999999999</c:v>
                </c:pt>
                <c:pt idx="15">
                  <c:v>1441.79</c:v>
                </c:pt>
                <c:pt idx="16">
                  <c:v>1621.71</c:v>
                </c:pt>
                <c:pt idx="17">
                  <c:v>1811.67</c:v>
                </c:pt>
                <c:pt idx="18">
                  <c:v>2010.11</c:v>
                </c:pt>
                <c:pt idx="19">
                  <c:v>2215.11</c:v>
                </c:pt>
                <c:pt idx="20">
                  <c:v>2424.41</c:v>
                </c:pt>
                <c:pt idx="21">
                  <c:v>2635.43</c:v>
                </c:pt>
                <c:pt idx="22">
                  <c:v>2845.33</c:v>
                </c:pt>
                <c:pt idx="23">
                  <c:v>3051.04</c:v>
                </c:pt>
                <c:pt idx="24">
                  <c:v>3249.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629E-4E28-A36F-3469303E4F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73084928"/>
        <c:axId val="73086848"/>
      </c:lineChart>
      <c:catAx>
        <c:axId val="73084928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Gestational age(weeks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40447610524000227"/>
              <c:y val="0.9482738805376600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3086848"/>
        <c:crosses val="autoZero"/>
        <c:auto val="1"/>
        <c:lblAlgn val="ctr"/>
        <c:lblOffset val="100"/>
        <c:noMultiLvlLbl val="0"/>
      </c:catAx>
      <c:valAx>
        <c:axId val="73086848"/>
        <c:scaling>
          <c:orientation val="minMax"/>
        </c:scaling>
        <c:delete val="0"/>
        <c:axPos val="l"/>
        <c:min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Estimate fetal weight (g)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9.5816495957523097E-3"/>
              <c:y val="0.3535210371430843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73084928"/>
        <c:crosses val="autoZero"/>
        <c:crossBetween val="midCat"/>
      </c:valAx>
    </c:plotArea>
    <c:legend>
      <c:legendPos val="r"/>
      <c:overlay val="0"/>
    </c:legend>
    <c:plotVisOnly val="1"/>
    <c:dispBlanksAs val="gap"/>
    <c:showDLblsOverMax val="0"/>
  </c:chart>
  <c:spPr>
    <a:ln>
      <a:solidFill>
        <a:schemeClr val="accent1"/>
      </a:solidFill>
    </a:ln>
  </c:spPr>
  <c:txPr>
    <a:bodyPr/>
    <a:lstStyle/>
    <a:p>
      <a:pPr>
        <a:defRPr sz="1400"/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5811</cdr:x>
      <cdr:y>0.05026</cdr:y>
    </cdr:from>
    <cdr:to>
      <cdr:x>0.25639</cdr:x>
      <cdr:y>0.05026</cdr:y>
    </cdr:to>
    <cdr:cxnSp macro="">
      <cdr:nvCxnSpPr>
        <cdr:cNvPr id="2" name="直接连接符 1">
          <a:extLst xmlns:a="http://schemas.openxmlformats.org/drawingml/2006/main">
            <a:ext uri="{FF2B5EF4-FFF2-40B4-BE49-F238E27FC236}">
              <a16:creationId xmlns:a16="http://schemas.microsoft.com/office/drawing/2014/main" id="{B57B2ADE-4BDD-4B9E-8C50-48F991156059}"/>
            </a:ext>
          </a:extLst>
        </cdr:cNvPr>
        <cdr:cNvCxnSpPr/>
      </cdr:nvCxnSpPr>
      <cdr:spPr>
        <a:xfrm xmlns:a="http://schemas.openxmlformats.org/drawingml/2006/main">
          <a:off x="1319285" y="257539"/>
          <a:ext cx="820025" cy="0"/>
        </a:xfrm>
        <a:prstGeom xmlns:a="http://schemas.openxmlformats.org/drawingml/2006/main" prst="line">
          <a:avLst/>
        </a:prstGeom>
        <a:ln xmlns:a="http://schemas.openxmlformats.org/drawingml/2006/main" w="25400">
          <a:solidFill>
            <a:srgbClr val="C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2615</cdr:x>
      <cdr:y>0.05099</cdr:y>
    </cdr:from>
    <cdr:to>
      <cdr:x>0.62444</cdr:x>
      <cdr:y>0.05099</cdr:y>
    </cdr:to>
    <cdr:cxnSp macro="">
      <cdr:nvCxnSpPr>
        <cdr:cNvPr id="3" name="直接连接符 2">
          <a:extLst xmlns:a="http://schemas.openxmlformats.org/drawingml/2006/main">
            <a:ext uri="{FF2B5EF4-FFF2-40B4-BE49-F238E27FC236}">
              <a16:creationId xmlns:a16="http://schemas.microsoft.com/office/drawing/2014/main" id="{5FFC568E-B611-49CE-ADC6-61157A459910}"/>
            </a:ext>
          </a:extLst>
        </cdr:cNvPr>
        <cdr:cNvCxnSpPr/>
      </cdr:nvCxnSpPr>
      <cdr:spPr>
        <a:xfrm xmlns:a="http://schemas.openxmlformats.org/drawingml/2006/main">
          <a:off x="4390136" y="261314"/>
          <a:ext cx="820107" cy="0"/>
        </a:xfrm>
        <a:prstGeom xmlns:a="http://schemas.openxmlformats.org/drawingml/2006/main" prst="line">
          <a:avLst/>
        </a:prstGeom>
        <a:ln xmlns:a="http://schemas.openxmlformats.org/drawingml/2006/main" w="25400">
          <a:solidFill>
            <a:srgbClr val="7030A0"/>
          </a:solidFill>
          <a:prstDash val="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18</cdr:x>
      <cdr:y>0.02292</cdr:y>
    </cdr:from>
    <cdr:to>
      <cdr:x>0.50228</cdr:x>
      <cdr:y>0.06877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184399" y="117475"/>
          <a:ext cx="2006599" cy="234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400" b="1" dirty="0"/>
            <a:t>Twins  naturally conceived</a:t>
          </a:r>
          <a:endParaRPr lang="zh-CN" altLang="en-US" sz="1400" b="1" dirty="0"/>
        </a:p>
      </cdr:txBody>
    </cdr:sp>
  </cdr:relSizeAnchor>
  <cdr:relSizeAnchor xmlns:cdr="http://schemas.openxmlformats.org/drawingml/2006/chartDrawing">
    <cdr:from>
      <cdr:x>0.6328</cdr:x>
      <cdr:y>0.02107</cdr:y>
    </cdr:from>
    <cdr:to>
      <cdr:x>0.87329</cdr:x>
      <cdr:y>0.06691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5280025" y="107950"/>
          <a:ext cx="2006599" cy="234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zh-CN" sz="1400" b="1" dirty="0"/>
            <a:t>Twins  conceived by IVF</a:t>
          </a:r>
          <a:endParaRPr lang="zh-CN" altLang="en-US" sz="14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572948-9D4A-4462-87A5-913C2D83DF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053C600-0B1E-4891-A579-C923B48037A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C06634-8134-43F2-8BCF-45B8EC725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D14748-4D9F-463B-989A-2CEFA58B9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55E320-FD4A-4379-BEB0-570E732F2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0503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B2B8BE-355C-4306-9BBD-DC47C95E46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524C91-4F05-4041-9CA2-FF6F4F3340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169B93-CCA3-4711-987A-A42F2088B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51BA56-20AC-4BF9-A0F8-BF818CA5C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7F2BC9-312F-4464-B695-B73E2234B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0711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D5ADE86-E0EC-42A7-8B74-A06895E00B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AC59608-9796-4A86-939F-33EC0F6291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437ECB6-B6E0-4823-B5AD-1DF01309BF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AD8544-8201-45ED-B0E9-0037BABD3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2EFE4BE-D86C-461C-BD38-6EA79BDE3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855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ED4A7D9-A109-4871-A49B-B85C59DADF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A8145F7-8E35-4041-9371-A7D73B492F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30D6E7-62B6-4348-A267-5257E97D91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662802C-9F86-4FCC-A823-974F34871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D04E863-BEE5-4830-9163-0577DAE70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4432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B350D6-03BE-4CE2-AA77-489DB7E764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1DAA5B3-A3B2-4DAD-98A4-A963D7E5936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8697F09-9764-42D7-8CA3-237729BBB2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52AB32-3CBA-45FA-B2CC-391B0864A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74CD6D-5CF1-47C4-BCB7-5F2C445CB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9770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C3DB6B-D726-4CD1-9B53-A5A0EB4F5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FDD8FEA-3361-4FB5-9B97-89DE5EF59F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119E52A-A956-4A46-B882-EACDA5B3A4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B9D899-94C9-448F-A693-1772D3F64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5E4611-031C-4AC7-A447-870747071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3B4A9D-4345-4BCF-9BE5-CEF94D5A6B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806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F4E02F-A310-4A23-9AA3-5339D54519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923E7D-6040-4D44-8D3F-DD96B55DC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852C028-06E6-4A5E-941A-4A0BCA9A85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F479CFF-6F8D-49B7-9054-D51F7074B3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D2115B4-B2E4-4A4B-B704-70D7EC744E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1DDB3E7-DFE2-4D56-811D-699B66D671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7B65BA3-6133-4342-B0DB-2181F4B12A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03F49B9-03D4-48C6-B956-2F9800299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9517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43DEE3-57F1-438C-B8CC-26762F083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3715C87-98A9-4BE3-9022-A02459A35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7CDF8FA-6D92-4D52-AD30-943D2724A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5F0D435-7B9E-4728-9B83-CD934D8E8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7374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2E000CC-71C2-4793-AEF7-CE8076B63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98E8571-45F0-4D70-8CF5-5D048A3CE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CDC4155-B2AE-44F4-88BF-72F2D09E2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7969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8E748B-BD29-478F-822D-CE21EF5FE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6F910B-EA90-4BBD-B895-6A8E550D95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99B3AF4-FF64-4131-85D0-9EC37B75B7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F815358-4594-48D0-8AE2-62FE00F843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632205-EF45-497E-9E4A-C68CAD54E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E5216DA-7D8C-4CFE-A62E-793D3719F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1093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A859986-C8F8-46E3-8ED4-DD35A1F03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82A2C77-8945-4E67-AFBD-4359C1D22E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09A393-B3F0-4466-B637-50B9022CE1A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BD9A7CC-A7F5-4248-9378-543C15228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7A33709-5233-47DE-82DC-02C27470A1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67649B-7B71-40EC-9F90-DF27A069B4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9171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0A43A80-EF11-4F54-8D40-391EFD3BF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947FE2E-1143-485C-A79B-9AD92E0741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EC417C-9706-48C9-9D00-BF666576E0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33C9AE-DFE3-469B-BF60-918FA49290E7}" type="datetimeFigureOut">
              <a:rPr lang="zh-CN" altLang="en-US" smtClean="0"/>
              <a:t>2021/6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7FFDC9-6288-4719-B9A1-610B90D344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51EEF2E-9854-48A7-83D5-B72D4DD8A0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A3D8E-31C4-4A7B-BD08-A7707079DE9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6766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3970820"/>
              </p:ext>
            </p:extLst>
          </p:nvPr>
        </p:nvGraphicFramePr>
        <p:xfrm>
          <a:off x="975360" y="169594"/>
          <a:ext cx="10383520" cy="6146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文本框 4">
            <a:extLst>
              <a:ext uri="{FF2B5EF4-FFF2-40B4-BE49-F238E27FC236}">
                <a16:creationId xmlns:a16="http://schemas.microsoft.com/office/drawing/2014/main" id="{A2D26AD9-DEEF-439C-8FD0-266EAE9DF12C}"/>
              </a:ext>
            </a:extLst>
          </p:cNvPr>
          <p:cNvSpPr txBox="1"/>
          <p:nvPr/>
        </p:nvSpPr>
        <p:spPr>
          <a:xfrm>
            <a:off x="833120" y="6437868"/>
            <a:ext cx="1113536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Supplementary Figure S1</a:t>
            </a:r>
            <a:r>
              <a:rPr lang="en-US" altLang="zh-CN" b="0" i="0" dirty="0">
                <a:solidFill>
                  <a:srgbClr val="111111"/>
                </a:solidFill>
                <a:effectLst/>
                <a:latin typeface="Times New Roman" panose="02020603050405020304" pitchFamily="18" charset="0"/>
              </a:rPr>
              <a:t>. Growth chart for twins conceived naturally and twins conceived by in vitro fertilizatio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9609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35</Words>
  <Application>Microsoft Office PowerPoint</Application>
  <PresentationFormat>宽屏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ulia</dc:creator>
  <cp:lastModifiedBy>julia</cp:lastModifiedBy>
  <cp:revision>3</cp:revision>
  <dcterms:created xsi:type="dcterms:W3CDTF">2021-06-19T13:09:54Z</dcterms:created>
  <dcterms:modified xsi:type="dcterms:W3CDTF">2021-06-19T13:39:19Z</dcterms:modified>
</cp:coreProperties>
</file>